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DAC2D7-8AED-4756-B642-3172959A0E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8FB2529-94C0-4983-A675-2DAB813A1E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34AEEB-69E8-41ED-ABF6-C2C86EB92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67AC9E3-F3FE-405A-BCC4-287D86B42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6F24DA7-DA73-4D6E-A37C-E4A3EDDEE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2791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BF225AD-278A-460C-BFBC-9F34DF4D75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2EC0963-AA98-4A48-BCF6-5D2A5AC272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8798352-EA9E-419E-8918-C685E1464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D96A3B3-DFE6-4B36-9071-B894C3383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7AD1690-E78F-4EC5-9840-6C16F4A00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083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B8A5B51-D9F8-4C62-A78C-BF83B8ED47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AC8BB11-8686-4D4B-9D9E-071B9844F2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31A23B-4DB8-4830-94FE-471EFB68F3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3FEC9F-8A87-48B9-BFAB-FF19512D8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2B40DCD-F062-4165-9039-62D212845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3417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01EF9BF-7E64-4518-8E5B-4C4E93465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1ABAA23-0869-43A7-9F8F-377EDE9034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4E34630-F1CC-451E-B08A-FABEDCD15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1DEBC6-EE80-4157-A764-2FE288DA4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038493C-87CA-4EE9-869D-C22D0651A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5458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F8C97A4-FED1-4B8A-B3B4-1C5153D1B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0C9AE8E-D153-4248-9C30-8EAB735B17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95978A8-7A16-4FFF-8364-928D1034B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055CCD2-58B7-4974-8603-716B54426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96627E4-F4D0-4CFE-9EF5-A1716E855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0769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5C2FCBD-BCF3-497E-AECA-0E21F5482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3EAB914-3A0B-43C7-AD2A-5C95E476A4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F781978-6D57-471C-B5FD-347A2BFB8A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8A5F7D1-03DE-4C92-988C-98909B2D8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69BFDE4-7090-4EF6-BE20-E53788ABD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DF810C6-2423-46E1-BACD-87534C9DF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2734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D4A248-D8EA-4783-A3F5-6A6116CC3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E868BB1-505D-46B2-9A93-57716D55D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C3AFD4F-44DC-491E-AD84-993C98232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C3F7B08-56D9-4EFC-9E26-F301049B57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F6458E4-77A3-4193-A768-520AC5481D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B13387B-5083-41FE-BDDA-4E89BEE05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C79E8D9-5B74-475E-B1AF-A67F2B99B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7558D70-C630-4FFE-B0A1-FF2E13886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6110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6B19E7-28C3-42D4-83B8-2CF599A2B7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6805E11-C66A-46A2-913E-33FDCDA88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1EC6AC1-1925-4C2D-801B-DB0E075E8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77F5CFF-7782-412F-BD32-3076F5A6E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8891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EF3CDAAC-5518-4933-A222-9361C8174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8B09676-D10D-4096-B360-16EFA1EB7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E18993A-D50F-43EC-81BD-14D90C7B8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244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A48E6D-F1F9-4A6A-9D47-6FA05CD78F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9471C6F-8789-493E-BFE8-61DA0AE6B1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2AB8A77-DA6B-4FD6-8D8F-5A738C82AD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FFF3879-273F-471F-8E51-BED023E6B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5D59D36-F865-4FA3-A451-65F0E8790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50FE7B6-C178-4375-B859-C9E3BAD3C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7990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91AAB38-C248-4977-8D2D-74ABA927E0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463BF05-13DB-456C-8D61-81552B4779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093C935-FB9E-4534-850D-DBE363F44C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70A54FD-E6C3-48F7-9758-F193524E6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AD14A54-6EC5-48A6-9496-BA42C449C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3821C3A-B49A-428D-8A9A-620C654B4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4815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38FAB0D-F02B-4E3C-9F42-27C485B6D1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59E3A1C-D30D-4515-A3B1-6E996C0BF3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D39027-0491-4BFE-BA2E-91AA23FB7E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28DCE-6001-400A-92F5-80FE325F33B0}" type="datetimeFigureOut">
              <a:rPr lang="de-DE" smtClean="0"/>
              <a:t>10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A74F30-0DE7-4F0B-AEE5-680B5B4F17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46DA233-1D3A-44AD-9C9D-6D354233F0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45289-E3D1-4C3B-8566-2541991C1A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241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F52D7E71-5298-4F47-B66B-15942DE271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7231" y="1131618"/>
            <a:ext cx="5497537" cy="3923645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D8996DA5-B78A-4423-9919-6DD3B19BBC8D}"/>
              </a:ext>
            </a:extLst>
          </p:cNvPr>
          <p:cNvSpPr txBox="1"/>
          <p:nvPr/>
        </p:nvSpPr>
        <p:spPr>
          <a:xfrm>
            <a:off x="687898" y="310393"/>
            <a:ext cx="2301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igure</a:t>
            </a: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D9B76F9B-D93F-486B-A04C-6F70D6826FC2}"/>
              </a:ext>
            </a:extLst>
          </p:cNvPr>
          <p:cNvSpPr/>
          <p:nvPr/>
        </p:nvSpPr>
        <p:spPr>
          <a:xfrm>
            <a:off x="3347231" y="5235954"/>
            <a:ext cx="5497537" cy="9664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Smartphone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screenshots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digital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tests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):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Tip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Test (TT), digital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connectio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test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dNCT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modified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Stroop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Times New Roman" panose="02020603050405020304" pitchFamily="18" charset="0"/>
              </a:rPr>
              <a:t> Test. 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6852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yk, Friedhelm</dc:creator>
  <cp:lastModifiedBy>Sayk, Friedhelm</cp:lastModifiedBy>
  <cp:revision>1</cp:revision>
  <dcterms:created xsi:type="dcterms:W3CDTF">2025-02-10T15:34:49Z</dcterms:created>
  <dcterms:modified xsi:type="dcterms:W3CDTF">2025-02-10T15:35:17Z</dcterms:modified>
</cp:coreProperties>
</file>